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6"/>
  </p:notesMasterIdLst>
  <p:sldIdLst>
    <p:sldId id="279" r:id="rId3"/>
    <p:sldId id="256" r:id="rId4"/>
    <p:sldId id="280" r:id="rId5"/>
  </p:sldIdLst>
  <p:sldSz cx="12192000" cy="6858000"/>
  <p:notesSz cx="6954838" cy="92408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4" autoAdjust="0"/>
    <p:restoredTop sz="95890" autoAdjust="0"/>
  </p:normalViewPr>
  <p:slideViewPr>
    <p:cSldViewPr snapToGrid="0">
      <p:cViewPr varScale="1">
        <p:scale>
          <a:sx n="62" d="100"/>
          <a:sy n="62" d="100"/>
        </p:scale>
        <p:origin x="82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763" cy="463647"/>
          </a:xfrm>
          <a:prstGeom prst="rect">
            <a:avLst/>
          </a:prstGeom>
        </p:spPr>
        <p:txBody>
          <a:bodyPr vert="horz" lIns="92546" tIns="46273" rIns="92546" bIns="4627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9466" y="0"/>
            <a:ext cx="3013763" cy="463647"/>
          </a:xfrm>
          <a:prstGeom prst="rect">
            <a:avLst/>
          </a:prstGeom>
        </p:spPr>
        <p:txBody>
          <a:bodyPr vert="horz" lIns="92546" tIns="46273" rIns="92546" bIns="46273" rtlCol="0"/>
          <a:lstStyle>
            <a:lvl1pPr algn="r">
              <a:defRPr sz="1200"/>
            </a:lvl1pPr>
          </a:lstStyle>
          <a:p>
            <a:fld id="{FB629CC1-E0F8-4F3A-9F50-1B392484231D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06438" y="1155700"/>
            <a:ext cx="5541962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546" tIns="46273" rIns="92546" bIns="4627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484" y="4447153"/>
            <a:ext cx="5563870" cy="3638580"/>
          </a:xfrm>
          <a:prstGeom prst="rect">
            <a:avLst/>
          </a:prstGeom>
        </p:spPr>
        <p:txBody>
          <a:bodyPr vert="horz" lIns="92546" tIns="46273" rIns="92546" bIns="4627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7193"/>
            <a:ext cx="3013763" cy="463646"/>
          </a:xfrm>
          <a:prstGeom prst="rect">
            <a:avLst/>
          </a:prstGeom>
        </p:spPr>
        <p:txBody>
          <a:bodyPr vert="horz" lIns="92546" tIns="46273" rIns="92546" bIns="4627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9466" y="8777193"/>
            <a:ext cx="3013763" cy="463646"/>
          </a:xfrm>
          <a:prstGeom prst="rect">
            <a:avLst/>
          </a:prstGeom>
        </p:spPr>
        <p:txBody>
          <a:bodyPr vert="horz" lIns="92546" tIns="46273" rIns="92546" bIns="46273" rtlCol="0" anchor="b"/>
          <a:lstStyle>
            <a:lvl1pPr algn="r">
              <a:defRPr sz="1200"/>
            </a:lvl1pPr>
          </a:lstStyle>
          <a:p>
            <a:fld id="{C993FB71-2F55-4A56-988E-013639211F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298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defTabSz="925464">
              <a:defRPr/>
            </a:pPr>
            <a:fld id="{8B110E4A-A3C6-A048-9EB0-A8FABD19C6DD}" type="slidenum">
              <a:rPr lang="en-US">
                <a:solidFill>
                  <a:prstClr val="black"/>
                </a:solidFill>
                <a:latin typeface="Aptos" panose="02110004020202020204"/>
              </a:rPr>
              <a:pPr defTabSz="925464">
                <a:defRPr/>
              </a:pPr>
              <a:t>2</a:t>
            </a:fld>
            <a:endParaRPr lang="en-US">
              <a:solidFill>
                <a:prstClr val="black"/>
              </a:solidFill>
              <a:latin typeface="Aptos" panose="02110004020202020204"/>
            </a:endParaRPr>
          </a:p>
        </p:txBody>
      </p:sp>
    </p:spTree>
    <p:extLst>
      <p:ext uri="{BB962C8B-B14F-4D97-AF65-F5344CB8AC3E}">
        <p14:creationId xmlns:p14="http://schemas.microsoft.com/office/powerpoint/2010/main" val="13471222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993FB71-2F55-4A56-988E-013639211F8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1355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75556-E626-78C6-79F4-AA18439ED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0022E2-10B3-2633-1D4D-AD00505BE9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83F91E-F3AB-AC50-3055-B5B3F0882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0667F2-C454-9642-6101-67B72C377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233568-B40F-EC15-DB73-DD9000B07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967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280C02-F6B8-A819-35C5-1529D02DF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CD5157-56C1-2901-F52E-B4D5D7BB38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4DAF9F-7F65-46CC-5B17-83CCB5632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FF33EC-C7F5-A24A-259F-3F048389F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4F847A-0C97-B1B9-05E2-1FBAFC1D8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409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79E6EA-ED67-95C9-ADB4-5B38B69A60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A15C0D-E6AC-24A6-5027-B78E7921FF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864970-3745-146A-988E-11190E746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38AA35-7EC5-C658-64DF-B7F709D80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BD9B2A-D384-1B7B-1D1B-94BFD0995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7035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18EEB-5B99-DFFF-2667-10301328D7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4BFCE5-FBD7-5E5B-946A-DB87F28CC6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BB352-BD38-AB64-3853-47F90B0C3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47218D-27E0-341D-0F82-5B5F5BF21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F05640-00C1-5AB8-88A9-09DF4829E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40600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3F66F-FD77-6A51-A58B-6B8FECC371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E20853-1358-A939-937F-76932E109B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D004EB-3A6B-9D07-5282-AE8533851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12F999-1C2F-EFD7-EDD9-A4DEFAB86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5BA25C-C2FD-2641-414B-FA3D0F826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72369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FD6F67-5054-E534-6F37-0D727A7B1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8890F4-4B4B-60CF-E9C2-B683923746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FF71CD-B7EA-7A04-8CAC-45BE4C083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4664D-E31D-5D46-4532-ADEFE4E5A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F182B0-9DBF-06E0-0B12-CEF3291FE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56853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2FF580-8B8A-0097-707D-3C1DE3E36B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3B8FC5-1EA6-7B60-DC03-1CDD7AC286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0B2B5D-E3BF-99F6-2AE7-F83609362E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012CA1-CA41-BFB2-8FF3-15C676E5E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CC7A0F-7448-17F5-2C19-3A6977A6D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723D18-7824-ABD4-468B-2E4B48F71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51942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F1037-987E-6252-8174-1EF36FA4D3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17445D-CB1C-E263-EA6D-7BA6F7164C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A40A91-3CFF-D1D8-5758-CB89968E57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B52CD0-BCD5-272B-B561-7434D9BA92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FAA3BA-2828-6D8C-E018-3ED6636923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80E0847-A22F-695A-0391-27771F641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1018A5D-EC8F-C84E-EA87-BB3840B31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82199F-97A8-51F7-C72F-636281DB4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68092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ECCB6-EDA0-83E9-770F-E1AD292804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EE9E521-9EFE-73E6-457D-658CA35A1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D36D7B-C0C6-E736-F4E2-7A546B660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A1B89E-9879-03DE-4FA3-F372B06EA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49571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D87075F-CF2D-A639-253C-A67738ABB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E71068-40EF-AFE2-E1C4-CAE7E08BC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69E6BB-B194-BE12-7CA9-6E17AAD3D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04195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967CF2-6717-58CF-961E-89BBC37BF9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EEBD26-95BD-D856-9CCC-E8162A6A6C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E3ECB6-0D50-42E5-C05E-766B13DAD8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009FAB-FE90-ED72-D6D2-2CB5FB1F2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E0D97C-4FB5-B482-2C65-F8D55EE7E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A6DC81-9465-CA08-9380-084D71708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372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B07A09-77C8-45DA-B33A-247F3E21EC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C80E69-291F-F9E4-2906-C963E5EC65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B1A4B4-6603-752A-125A-35D4C2BEC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157739-48D2-43EA-EF46-D2B74D843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CB46BA-643A-72E0-27C1-543BAE3FE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84244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0E8A1B-D69B-7AE5-5580-3EF51F93C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BD32A4-3A70-0A84-5908-EEF9BCDE38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1BFA66-BE9B-CD0E-0E64-655D723735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F548BC-2C27-53C6-CF8E-9A1C95244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275F64-8818-2D32-DFE9-779E4F51E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767299-5E61-B03B-D672-C56DE6814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74443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FB5FA3-2721-F16E-41C5-2EE34571BD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642FDD-BBBB-0EAF-B86B-F60AE2730E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1DCDCA-2ECE-6B11-EC84-7E4F29A79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4AB00C-5CAE-91AC-092C-2499D1022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941F25-65E4-7042-858F-6270D64C2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59288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01F7BAD-77D0-54DA-E503-40619A34AC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267C87-A8A7-D418-8072-DED177FFA5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075201-046D-A36F-AA5B-4CA708A9E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9BF0EF-F70E-3809-7C63-E4ABE0197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14730-DB5A-4BA7-9803-7550ED23C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243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B45C56-7734-8E12-2BB0-3B4C61BC73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1A1584-E9B9-70C1-FB0B-80FD303B25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1AA3BF-54DD-6C6F-7142-E8221CB04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CA3EE6-534A-328D-263C-49758715C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D9067D-6CAB-BAC1-50C4-72B486D18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973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CD6F5D-BDAB-EEC8-E6C3-D5595DD656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B1CE80-7BC4-2101-71C3-0BE82AF0E8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C8A7D4-F0A5-4F99-2BD2-FF8809EE27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0FDBE1-EA25-2C6E-030C-148DC2100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334418-A393-53E3-FFBA-957E05155E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486392-5837-E7AE-23CC-41B6CF667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552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B8CE70-38F4-B5C1-7262-37E9302DE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098E41-5856-34F6-0BA8-6B6DAF8DA6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72F1FF-EE58-D21C-44E0-80A58D5A53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586AC16-E528-3D8A-82F1-8E17038F32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7BF035-DCED-9160-E149-E0B6271655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1D613B-F57D-3C29-3EC8-797BD8036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AAAF46-EC15-4B70-DD0C-8B848CFC6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FC8B5DD-87E9-916A-F61E-54A602CE7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037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C0A26-F27E-87F3-0EC7-2541C0783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CF4E8C-BDBD-47B5-8797-D8FA4AAE7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7AE08E-ED4D-183E-6A56-89BA7CE26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16D021-C995-D8F4-1C18-B2410CF10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98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865CA0-36A8-49D4-C04A-6E8E8814C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E35435-5AC9-ECD1-E3F8-CBCCB1712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6B3E38-6DF7-7C6C-F973-1F77F6CE4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565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9DBD01-4F07-AD59-74F2-22DB14E2A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BB9678-0FC0-B7F7-D105-F16B76080B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8311A3-B2A7-6AB2-96D2-789B500DAC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ED5B41-B393-23A0-2486-B8523AF6F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FE6971-73AE-1A24-79DA-04E8B45F7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8634A4-BD3D-4028-6A42-E679525AC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603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352658-AB12-56ED-4F44-7779B4B09A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DF0ABE-0CBD-E2C5-E644-F27EDE45D4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04D39B-9F38-4166-1BA0-A1E9110614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73BD64-5A67-C848-F8D8-04F55925C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0A6355-64A5-7390-0F94-AD88C25CD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99D90-9806-ECE9-0660-A4B6994BB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537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943DA0-4AE1-1DEF-E330-CAE2349D0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95FA07-A389-DD95-ADC9-A996AA9CF9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5D8868-0E30-96D8-3868-CDF3B2D648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B45A08-0411-4BFF-94EE-7B80A4E05261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1E399F-CE9E-3260-3A8B-440D936272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82FBB8-C39E-3EBB-4D17-80B9AA1316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A3DBD-E927-4723-9160-8E6E9AC2C2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047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EBE237-2359-2E34-0CC2-B6FB51B7E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FC0EA2-801D-9F93-9780-E583CB201F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DA5C11-C668-997C-B2B6-F9664F92D1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CA37D3-2C70-014E-B744-B02A87892A6C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AE641D-F3E4-0B98-6481-B75133A669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C041C7-B187-6AB7-3420-21F799A276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27554D4-90D9-204A-BB5A-3A4C6FBD6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584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 figures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9808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180B4308-9B61-7F02-9C39-71748B23C722}"/>
              </a:ext>
            </a:extLst>
          </p:cNvPr>
          <p:cNvSpPr txBox="1"/>
          <p:nvPr/>
        </p:nvSpPr>
        <p:spPr>
          <a:xfrm>
            <a:off x="7422366" y="440014"/>
            <a:ext cx="32919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rotein association with APOE genotypes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6F55F3A-0CDA-BB4B-8FF6-B423DFB53719}"/>
              </a:ext>
            </a:extLst>
          </p:cNvPr>
          <p:cNvSpPr txBox="1"/>
          <p:nvPr/>
        </p:nvSpPr>
        <p:spPr>
          <a:xfrm>
            <a:off x="7109902" y="87714"/>
            <a:ext cx="378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b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86119283-EDFE-7F82-C893-064542A4BC62}"/>
              </a:ext>
            </a:extLst>
          </p:cNvPr>
          <p:cNvSpPr/>
          <p:nvPr/>
        </p:nvSpPr>
        <p:spPr>
          <a:xfrm>
            <a:off x="5760597" y="6072143"/>
            <a:ext cx="472035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≈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E23CC187-C8E5-7C90-34B5-B82222B7DF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7514" y="762684"/>
            <a:ext cx="4263058" cy="568407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0E2F2767-C817-8596-BD37-2821FDB45FF1}"/>
              </a:ext>
            </a:extLst>
          </p:cNvPr>
          <p:cNvSpPr txBox="1"/>
          <p:nvPr/>
        </p:nvSpPr>
        <p:spPr>
          <a:xfrm rot="16200000">
            <a:off x="10378903" y="2221351"/>
            <a:ext cx="105507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600" baseline="-25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2AFC52F-71D0-562F-7056-AD8FD0BCD1EA}"/>
              </a:ext>
            </a:extLst>
          </p:cNvPr>
          <p:cNvSpPr txBox="1"/>
          <p:nvPr/>
        </p:nvSpPr>
        <p:spPr>
          <a:xfrm>
            <a:off x="275588" y="87714"/>
            <a:ext cx="378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a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8518516"/>
              </p:ext>
            </p:extLst>
          </p:nvPr>
        </p:nvGraphicFramePr>
        <p:xfrm>
          <a:off x="238011" y="1117818"/>
          <a:ext cx="7061200" cy="4086225"/>
        </p:xfrm>
        <a:graphic>
          <a:graphicData uri="http://schemas.openxmlformats.org/drawingml/2006/table">
            <a:tbl>
              <a:tblPr>
                <a:tableStyleId>{2A488322-F2BA-4B5B-9748-0D474271808F}</a:tableStyleId>
              </a:tblPr>
              <a:tblGrid>
                <a:gridCol w="8260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0110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C e2e2/e3e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C e2e3/e3e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C e2e4/e3e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C e3e4/e3e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D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1B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5312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952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877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108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PO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21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534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363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1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4735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POC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21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34E-29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5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13E-2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4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033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1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9984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PO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23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E-17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20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E-11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87E-1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2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PO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6056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876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908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62E-1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POL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849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032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480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660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CH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760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858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8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408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326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505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389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688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TB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988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371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947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0375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NO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473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843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874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877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6</a:t>
                      </a:r>
                    </a:p>
                  </a:txBody>
                  <a:tcPr marL="9525" marR="9525" marT="9525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14828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1116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809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128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STL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3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999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62448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233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973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7</a:t>
                      </a:r>
                    </a:p>
                  </a:txBody>
                  <a:tcPr marL="9525" marR="9525" marT="9525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2636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52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572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654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S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152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8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202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83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P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62E-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98E-11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448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153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PO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476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95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769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700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L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514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15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17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220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RDX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412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286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508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911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Z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913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141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726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000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ERPINA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247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629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837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0598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123226" y="5433506"/>
            <a:ext cx="7175985" cy="12654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0000"/>
              </a:lnSpc>
              <a:spcAft>
                <a:spcPts val="60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 Figure S1: Protein association with APOE genotypes in the UK Biobank.  A.FC=fold changes. FDR= false discovery rate. b. Linear regression analysis on all participants. The colors in the heatmap denote the regression coefficients (</a:t>
            </a:r>
            <a:r>
              <a:rPr lang="en-US" sz="14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log</a:t>
            </a:r>
            <a:r>
              <a:rPr lang="en-US" sz="1400" baseline="-250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2</a:t>
            </a:r>
            <a:r>
              <a:rPr lang="en-US" sz="14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FC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for APOE genotypes (blue:</a:t>
            </a:r>
            <a:r>
              <a:rPr lang="en-US" sz="14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log</a:t>
            </a:r>
            <a:r>
              <a:rPr lang="en-US" sz="1400" baseline="-250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2</a:t>
            </a:r>
            <a:r>
              <a:rPr lang="en-US" sz="14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FC&lt;0, white: log</a:t>
            </a:r>
            <a:r>
              <a:rPr lang="en-US" sz="1400" baseline="-250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2</a:t>
            </a:r>
            <a:r>
              <a:rPr lang="en-US" sz="14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FC=0, red: log</a:t>
            </a:r>
            <a:r>
              <a:rPr lang="en-US" sz="1400" baseline="-250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2</a:t>
            </a:r>
            <a:r>
              <a:rPr lang="en-US" sz="1400" dirty="0">
                <a:solidFill>
                  <a:srgbClr val="1F1F1F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</a:rPr>
              <a:t>FC&gt;0</a:t>
            </a: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and asterisk symbols imply statistical significance: *FDR&lt;0.05, **FDR&lt;0.01, and ***FDR&lt;0.001.</a:t>
            </a:r>
          </a:p>
        </p:txBody>
      </p:sp>
    </p:spTree>
    <p:extLst>
      <p:ext uri="{BB962C8B-B14F-4D97-AF65-F5344CB8AC3E}">
        <p14:creationId xmlns:p14="http://schemas.microsoft.com/office/powerpoint/2010/main" val="7115481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D25AACA3-7F15-D19C-7653-49C13C4B8011}"/>
              </a:ext>
            </a:extLst>
          </p:cNvPr>
          <p:cNvGrpSpPr/>
          <p:nvPr/>
        </p:nvGrpSpPr>
        <p:grpSpPr>
          <a:xfrm>
            <a:off x="2589746" y="751026"/>
            <a:ext cx="7012507" cy="5355945"/>
            <a:chOff x="2589746" y="751026"/>
            <a:chExt cx="7012507" cy="5355945"/>
          </a:xfrm>
        </p:grpSpPr>
        <p:sp>
          <p:nvSpPr>
            <p:cNvPr id="6" name="Arrow: Bent-Up 5">
              <a:extLst>
                <a:ext uri="{FF2B5EF4-FFF2-40B4-BE49-F238E27FC236}">
                  <a16:creationId xmlns:a16="http://schemas.microsoft.com/office/drawing/2014/main" id="{E863A985-2BF2-DFD7-2124-97290FE1841D}"/>
                </a:ext>
              </a:extLst>
            </p:cNvPr>
            <p:cNvSpPr/>
            <p:nvPr/>
          </p:nvSpPr>
          <p:spPr>
            <a:xfrm rot="5400000">
              <a:off x="2865317" y="1904031"/>
              <a:ext cx="1040130" cy="1184151"/>
            </a:xfrm>
            <a:prstGeom prst="bentUpArrow">
              <a:avLst>
                <a:gd name="adj1" fmla="val 32840"/>
                <a:gd name="adj2" fmla="val 25000"/>
                <a:gd name="adj3" fmla="val 3578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5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5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7" name="Freeform: Shape 6">
              <a:extLst>
                <a:ext uri="{FF2B5EF4-FFF2-40B4-BE49-F238E27FC236}">
                  <a16:creationId xmlns:a16="http://schemas.microsoft.com/office/drawing/2014/main" id="{E8D34E72-9CDA-D1F9-4A30-748658098943}"/>
                </a:ext>
              </a:extLst>
            </p:cNvPr>
            <p:cNvSpPr/>
            <p:nvPr/>
          </p:nvSpPr>
          <p:spPr>
            <a:xfrm>
              <a:off x="2589746" y="751026"/>
              <a:ext cx="1750966" cy="1225619"/>
            </a:xfrm>
            <a:custGeom>
              <a:avLst/>
              <a:gdLst>
                <a:gd name="connsiteX0" fmla="*/ 0 w 1750966"/>
                <a:gd name="connsiteY0" fmla="*/ 204311 h 1225619"/>
                <a:gd name="connsiteX1" fmla="*/ 204311 w 1750966"/>
                <a:gd name="connsiteY1" fmla="*/ 0 h 1225619"/>
                <a:gd name="connsiteX2" fmla="*/ 1546655 w 1750966"/>
                <a:gd name="connsiteY2" fmla="*/ 0 h 1225619"/>
                <a:gd name="connsiteX3" fmla="*/ 1750966 w 1750966"/>
                <a:gd name="connsiteY3" fmla="*/ 204311 h 1225619"/>
                <a:gd name="connsiteX4" fmla="*/ 1750966 w 1750966"/>
                <a:gd name="connsiteY4" fmla="*/ 1021308 h 1225619"/>
                <a:gd name="connsiteX5" fmla="*/ 1546655 w 1750966"/>
                <a:gd name="connsiteY5" fmla="*/ 1225619 h 1225619"/>
                <a:gd name="connsiteX6" fmla="*/ 204311 w 1750966"/>
                <a:gd name="connsiteY6" fmla="*/ 1225619 h 1225619"/>
                <a:gd name="connsiteX7" fmla="*/ 0 w 1750966"/>
                <a:gd name="connsiteY7" fmla="*/ 1021308 h 1225619"/>
                <a:gd name="connsiteX8" fmla="*/ 0 w 1750966"/>
                <a:gd name="connsiteY8" fmla="*/ 204311 h 12256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750966" h="1225619">
                  <a:moveTo>
                    <a:pt x="0" y="204311"/>
                  </a:moveTo>
                  <a:cubicBezTo>
                    <a:pt x="0" y="91473"/>
                    <a:pt x="91473" y="0"/>
                    <a:pt x="204311" y="0"/>
                  </a:cubicBezTo>
                  <a:lnTo>
                    <a:pt x="1546655" y="0"/>
                  </a:lnTo>
                  <a:cubicBezTo>
                    <a:pt x="1659493" y="0"/>
                    <a:pt x="1750966" y="91473"/>
                    <a:pt x="1750966" y="204311"/>
                  </a:cubicBezTo>
                  <a:lnTo>
                    <a:pt x="1750966" y="1021308"/>
                  </a:lnTo>
                  <a:cubicBezTo>
                    <a:pt x="1750966" y="1134146"/>
                    <a:pt x="1659493" y="1225619"/>
                    <a:pt x="1546655" y="1225619"/>
                  </a:cubicBezTo>
                  <a:lnTo>
                    <a:pt x="204311" y="1225619"/>
                  </a:lnTo>
                  <a:cubicBezTo>
                    <a:pt x="91473" y="1225619"/>
                    <a:pt x="0" y="1134146"/>
                    <a:pt x="0" y="1021308"/>
                  </a:cubicBezTo>
                  <a:lnTo>
                    <a:pt x="0" y="204311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113181" tIns="113181" rIns="113181" bIns="113181" numCol="1" spcCol="1270" anchor="ctr" anchorCtr="0">
              <a:noAutofit/>
            </a:bodyPr>
            <a:lstStyle/>
            <a:p>
              <a:pPr marL="0" lvl="0" indent="0" algn="ctr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900" kern="1200" dirty="0" err="1"/>
                <a:t>Somascan</a:t>
              </a:r>
              <a:r>
                <a:rPr lang="en-US" sz="1900" kern="1200" dirty="0"/>
                <a:t>-based APOE2 signature</a:t>
              </a:r>
            </a:p>
          </p:txBody>
        </p:sp>
        <p:sp>
          <p:nvSpPr>
            <p:cNvPr id="8" name="Freeform: Shape 7">
              <a:extLst>
                <a:ext uri="{FF2B5EF4-FFF2-40B4-BE49-F238E27FC236}">
                  <a16:creationId xmlns:a16="http://schemas.microsoft.com/office/drawing/2014/main" id="{316FC4D8-2204-C7B6-9CCB-BC9FEFBE40FB}"/>
                </a:ext>
              </a:extLst>
            </p:cNvPr>
            <p:cNvSpPr/>
            <p:nvPr/>
          </p:nvSpPr>
          <p:spPr>
            <a:xfrm>
              <a:off x="4382514" y="846351"/>
              <a:ext cx="1713485" cy="990600"/>
            </a:xfrm>
            <a:custGeom>
              <a:avLst/>
              <a:gdLst>
                <a:gd name="connsiteX0" fmla="*/ 0 w 763544"/>
                <a:gd name="connsiteY0" fmla="*/ 0 h 990600"/>
                <a:gd name="connsiteX1" fmla="*/ 763544 w 763544"/>
                <a:gd name="connsiteY1" fmla="*/ 0 h 990600"/>
                <a:gd name="connsiteX2" fmla="*/ 763544 w 763544"/>
                <a:gd name="connsiteY2" fmla="*/ 990600 h 990600"/>
                <a:gd name="connsiteX3" fmla="*/ 0 w 763544"/>
                <a:gd name="connsiteY3" fmla="*/ 990600 h 990600"/>
                <a:gd name="connsiteX4" fmla="*/ 0 w 763544"/>
                <a:gd name="connsiteY4" fmla="*/ 0 h 990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763544" h="990600">
                  <a:moveTo>
                    <a:pt x="0" y="0"/>
                  </a:moveTo>
                  <a:lnTo>
                    <a:pt x="763544" y="0"/>
                  </a:lnTo>
                  <a:lnTo>
                    <a:pt x="763544" y="990600"/>
                  </a:lnTo>
                  <a:lnTo>
                    <a:pt x="0" y="9906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9530" tIns="49530" rIns="49530" bIns="49530" numCol="1" spcCol="1270" anchor="ctr" anchorCtr="0">
              <a:noAutofit/>
            </a:bodyPr>
            <a:lstStyle/>
            <a:p>
              <a:pPr marL="57150" lvl="1" indent="-57150" algn="l" defTabSz="4445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kern="1200" dirty="0"/>
                <a:t>16 proteins 1%FDR</a:t>
              </a:r>
            </a:p>
            <a:p>
              <a:pPr marL="57150" lvl="1" indent="-57150" algn="l" defTabSz="4445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kern="1200" dirty="0"/>
                <a:t>224 serum samples</a:t>
              </a:r>
            </a:p>
          </p:txBody>
        </p:sp>
        <p:sp>
          <p:nvSpPr>
            <p:cNvPr id="9" name="Arrow: Bent-Up 8">
              <a:extLst>
                <a:ext uri="{FF2B5EF4-FFF2-40B4-BE49-F238E27FC236}">
                  <a16:creationId xmlns:a16="http://schemas.microsoft.com/office/drawing/2014/main" id="{0A574A3E-7CD8-2506-1563-76312711DCF5}"/>
                </a:ext>
              </a:extLst>
            </p:cNvPr>
            <p:cNvSpPr/>
            <p:nvPr/>
          </p:nvSpPr>
          <p:spPr>
            <a:xfrm rot="5400000">
              <a:off x="4194669" y="3280806"/>
              <a:ext cx="1040130" cy="1184151"/>
            </a:xfrm>
            <a:prstGeom prst="bentUpArrow">
              <a:avLst>
                <a:gd name="adj1" fmla="val 32840"/>
                <a:gd name="adj2" fmla="val 25000"/>
                <a:gd name="adj3" fmla="val 3578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5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5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0" name="Freeform: Shape 9">
              <a:extLst>
                <a:ext uri="{FF2B5EF4-FFF2-40B4-BE49-F238E27FC236}">
                  <a16:creationId xmlns:a16="http://schemas.microsoft.com/office/drawing/2014/main" id="{07544B34-63BB-1397-F7D3-AA8CFC69B22E}"/>
                </a:ext>
              </a:extLst>
            </p:cNvPr>
            <p:cNvSpPr/>
            <p:nvPr/>
          </p:nvSpPr>
          <p:spPr>
            <a:xfrm>
              <a:off x="3919097" y="2127801"/>
              <a:ext cx="1750966" cy="1225619"/>
            </a:xfrm>
            <a:custGeom>
              <a:avLst/>
              <a:gdLst>
                <a:gd name="connsiteX0" fmla="*/ 0 w 1750966"/>
                <a:gd name="connsiteY0" fmla="*/ 204311 h 1225619"/>
                <a:gd name="connsiteX1" fmla="*/ 204311 w 1750966"/>
                <a:gd name="connsiteY1" fmla="*/ 0 h 1225619"/>
                <a:gd name="connsiteX2" fmla="*/ 1546655 w 1750966"/>
                <a:gd name="connsiteY2" fmla="*/ 0 h 1225619"/>
                <a:gd name="connsiteX3" fmla="*/ 1750966 w 1750966"/>
                <a:gd name="connsiteY3" fmla="*/ 204311 h 1225619"/>
                <a:gd name="connsiteX4" fmla="*/ 1750966 w 1750966"/>
                <a:gd name="connsiteY4" fmla="*/ 1021308 h 1225619"/>
                <a:gd name="connsiteX5" fmla="*/ 1546655 w 1750966"/>
                <a:gd name="connsiteY5" fmla="*/ 1225619 h 1225619"/>
                <a:gd name="connsiteX6" fmla="*/ 204311 w 1750966"/>
                <a:gd name="connsiteY6" fmla="*/ 1225619 h 1225619"/>
                <a:gd name="connsiteX7" fmla="*/ 0 w 1750966"/>
                <a:gd name="connsiteY7" fmla="*/ 1021308 h 1225619"/>
                <a:gd name="connsiteX8" fmla="*/ 0 w 1750966"/>
                <a:gd name="connsiteY8" fmla="*/ 204311 h 12256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750966" h="1225619">
                  <a:moveTo>
                    <a:pt x="0" y="204311"/>
                  </a:moveTo>
                  <a:cubicBezTo>
                    <a:pt x="0" y="91473"/>
                    <a:pt x="91473" y="0"/>
                    <a:pt x="204311" y="0"/>
                  </a:cubicBezTo>
                  <a:lnTo>
                    <a:pt x="1546655" y="0"/>
                  </a:lnTo>
                  <a:cubicBezTo>
                    <a:pt x="1659493" y="0"/>
                    <a:pt x="1750966" y="91473"/>
                    <a:pt x="1750966" y="204311"/>
                  </a:cubicBezTo>
                  <a:lnTo>
                    <a:pt x="1750966" y="1021308"/>
                  </a:lnTo>
                  <a:cubicBezTo>
                    <a:pt x="1750966" y="1134146"/>
                    <a:pt x="1659493" y="1225619"/>
                    <a:pt x="1546655" y="1225619"/>
                  </a:cubicBezTo>
                  <a:lnTo>
                    <a:pt x="204311" y="1225619"/>
                  </a:lnTo>
                  <a:cubicBezTo>
                    <a:pt x="91473" y="1225619"/>
                    <a:pt x="0" y="1134146"/>
                    <a:pt x="0" y="1021308"/>
                  </a:cubicBezTo>
                  <a:lnTo>
                    <a:pt x="0" y="204311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113181" tIns="113181" rIns="113181" bIns="113181" numCol="1" spcCol="1270" anchor="ctr" anchorCtr="0">
              <a:noAutofit/>
            </a:bodyPr>
            <a:lstStyle/>
            <a:p>
              <a:pPr marL="0" lvl="0" indent="0" algn="ctr" defTabSz="622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900" kern="1200" dirty="0" err="1"/>
                <a:t>nLC</a:t>
              </a:r>
              <a:r>
                <a:rPr lang="en-US" sz="1900" kern="1200" dirty="0"/>
                <a:t>-MS/MS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12352D74-270F-C12D-8DCE-DE15031B8C4B}"/>
                </a:ext>
              </a:extLst>
            </p:cNvPr>
            <p:cNvSpPr/>
            <p:nvPr/>
          </p:nvSpPr>
          <p:spPr>
            <a:xfrm>
              <a:off x="5657164" y="2245316"/>
              <a:ext cx="2380324" cy="990600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2" name="Arrow: Bent-Up 11">
              <a:extLst>
                <a:ext uri="{FF2B5EF4-FFF2-40B4-BE49-F238E27FC236}">
                  <a16:creationId xmlns:a16="http://schemas.microsoft.com/office/drawing/2014/main" id="{06EF9F27-7F68-327B-5B8F-B036F0903ECB}"/>
                </a:ext>
              </a:extLst>
            </p:cNvPr>
            <p:cNvSpPr/>
            <p:nvPr/>
          </p:nvSpPr>
          <p:spPr>
            <a:xfrm rot="5400000">
              <a:off x="5524020" y="4657582"/>
              <a:ext cx="1040130" cy="1184151"/>
            </a:xfrm>
            <a:prstGeom prst="bentUpArrow">
              <a:avLst>
                <a:gd name="adj1" fmla="val 32840"/>
                <a:gd name="adj2" fmla="val 25000"/>
                <a:gd name="adj3" fmla="val 3578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5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50000"/>
                <a:hueOff val="0"/>
                <a:satOff val="0"/>
                <a:lumOff val="0"/>
                <a:alphaOff val="0"/>
              </a:schemeClr>
            </a:effectRef>
            <a:fontRef idx="minor">
              <a:schemeClr val="lt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3" name="Freeform: Shape 12">
              <a:extLst>
                <a:ext uri="{FF2B5EF4-FFF2-40B4-BE49-F238E27FC236}">
                  <a16:creationId xmlns:a16="http://schemas.microsoft.com/office/drawing/2014/main" id="{15889318-7B24-0A24-C904-3CF029FF098B}"/>
                </a:ext>
              </a:extLst>
            </p:cNvPr>
            <p:cNvSpPr/>
            <p:nvPr/>
          </p:nvSpPr>
          <p:spPr>
            <a:xfrm>
              <a:off x="5248449" y="3504577"/>
              <a:ext cx="1750966" cy="1225619"/>
            </a:xfrm>
            <a:custGeom>
              <a:avLst/>
              <a:gdLst>
                <a:gd name="connsiteX0" fmla="*/ 0 w 1750966"/>
                <a:gd name="connsiteY0" fmla="*/ 204311 h 1225619"/>
                <a:gd name="connsiteX1" fmla="*/ 204311 w 1750966"/>
                <a:gd name="connsiteY1" fmla="*/ 0 h 1225619"/>
                <a:gd name="connsiteX2" fmla="*/ 1546655 w 1750966"/>
                <a:gd name="connsiteY2" fmla="*/ 0 h 1225619"/>
                <a:gd name="connsiteX3" fmla="*/ 1750966 w 1750966"/>
                <a:gd name="connsiteY3" fmla="*/ 204311 h 1225619"/>
                <a:gd name="connsiteX4" fmla="*/ 1750966 w 1750966"/>
                <a:gd name="connsiteY4" fmla="*/ 1021308 h 1225619"/>
                <a:gd name="connsiteX5" fmla="*/ 1546655 w 1750966"/>
                <a:gd name="connsiteY5" fmla="*/ 1225619 h 1225619"/>
                <a:gd name="connsiteX6" fmla="*/ 204311 w 1750966"/>
                <a:gd name="connsiteY6" fmla="*/ 1225619 h 1225619"/>
                <a:gd name="connsiteX7" fmla="*/ 0 w 1750966"/>
                <a:gd name="connsiteY7" fmla="*/ 1021308 h 1225619"/>
                <a:gd name="connsiteX8" fmla="*/ 0 w 1750966"/>
                <a:gd name="connsiteY8" fmla="*/ 204311 h 12256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750966" h="1225619">
                  <a:moveTo>
                    <a:pt x="0" y="204311"/>
                  </a:moveTo>
                  <a:cubicBezTo>
                    <a:pt x="0" y="91473"/>
                    <a:pt x="91473" y="0"/>
                    <a:pt x="204311" y="0"/>
                  </a:cubicBezTo>
                  <a:lnTo>
                    <a:pt x="1546655" y="0"/>
                  </a:lnTo>
                  <a:cubicBezTo>
                    <a:pt x="1659493" y="0"/>
                    <a:pt x="1750966" y="91473"/>
                    <a:pt x="1750966" y="204311"/>
                  </a:cubicBezTo>
                  <a:lnTo>
                    <a:pt x="1750966" y="1021308"/>
                  </a:lnTo>
                  <a:cubicBezTo>
                    <a:pt x="1750966" y="1134146"/>
                    <a:pt x="1659493" y="1225619"/>
                    <a:pt x="1546655" y="1225619"/>
                  </a:cubicBezTo>
                  <a:lnTo>
                    <a:pt x="204311" y="1225619"/>
                  </a:lnTo>
                  <a:cubicBezTo>
                    <a:pt x="91473" y="1225619"/>
                    <a:pt x="0" y="1134146"/>
                    <a:pt x="0" y="1021308"/>
                  </a:cubicBezTo>
                  <a:lnTo>
                    <a:pt x="0" y="204311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132231" tIns="132231" rIns="132231" bIns="132231" numCol="1" spcCol="1270" anchor="ctr" anchorCtr="0">
              <a:noAutofit/>
            </a:bodyPr>
            <a:lstStyle/>
            <a:p>
              <a:pPr marL="0" lvl="0" indent="0" algn="ctr" defTabSz="8445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900" kern="1200" dirty="0"/>
                <a:t>UK Biobank</a:t>
              </a:r>
            </a:p>
          </p:txBody>
        </p:sp>
        <p:sp>
          <p:nvSpPr>
            <p:cNvPr id="14" name="Freeform: Shape 13">
              <a:extLst>
                <a:ext uri="{FF2B5EF4-FFF2-40B4-BE49-F238E27FC236}">
                  <a16:creationId xmlns:a16="http://schemas.microsoft.com/office/drawing/2014/main" id="{0D83E31A-61A8-0CCC-E80F-37DD9ED11610}"/>
                </a:ext>
              </a:extLst>
            </p:cNvPr>
            <p:cNvSpPr/>
            <p:nvPr/>
          </p:nvSpPr>
          <p:spPr>
            <a:xfrm>
              <a:off x="5715525" y="2186559"/>
              <a:ext cx="2840587" cy="990600"/>
            </a:xfrm>
            <a:custGeom>
              <a:avLst/>
              <a:gdLst>
                <a:gd name="connsiteX0" fmla="*/ 0 w 2840587"/>
                <a:gd name="connsiteY0" fmla="*/ 0 h 990600"/>
                <a:gd name="connsiteX1" fmla="*/ 2840587 w 2840587"/>
                <a:gd name="connsiteY1" fmla="*/ 0 h 990600"/>
                <a:gd name="connsiteX2" fmla="*/ 2840587 w 2840587"/>
                <a:gd name="connsiteY2" fmla="*/ 990600 h 990600"/>
                <a:gd name="connsiteX3" fmla="*/ 0 w 2840587"/>
                <a:gd name="connsiteY3" fmla="*/ 990600 h 990600"/>
                <a:gd name="connsiteX4" fmla="*/ 0 w 2840587"/>
                <a:gd name="connsiteY4" fmla="*/ 0 h 990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840587" h="990600">
                  <a:moveTo>
                    <a:pt x="0" y="0"/>
                  </a:moveTo>
                  <a:lnTo>
                    <a:pt x="2840587" y="0"/>
                  </a:lnTo>
                  <a:lnTo>
                    <a:pt x="2840587" y="990600"/>
                  </a:lnTo>
                  <a:lnTo>
                    <a:pt x="0" y="9906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5720" tIns="45720" rIns="45720" bIns="45720" numCol="1" spcCol="1270" anchor="ctr" anchorCtr="0">
              <a:noAutofit/>
            </a:bodyPr>
            <a:lstStyle/>
            <a:p>
              <a:pPr marL="114300" lvl="1" indent="-114300" algn="l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kern="1200" dirty="0"/>
                <a:t>18 proteins at 1% FDR</a:t>
              </a:r>
            </a:p>
            <a:p>
              <a:pPr marL="114300" lvl="1" indent="-114300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FontTx/>
                <a:buChar char="•"/>
              </a:pPr>
              <a:r>
                <a:rPr lang="en-US" sz="1200" dirty="0"/>
                <a:t>39 proteins at 5%FDR</a:t>
              </a:r>
            </a:p>
            <a:p>
              <a:pPr marL="114300" lvl="1" indent="-114300" algn="l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kern="1200" dirty="0"/>
                <a:t>50 serum samples from the 224</a:t>
              </a:r>
            </a:p>
            <a:p>
              <a:pPr marL="114300" lvl="1" indent="-114300" algn="l" defTabSz="5334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r>
                <a:rPr lang="en-US" sz="1200" kern="1200" dirty="0"/>
                <a:t>Only APOB and APOE overlapped </a:t>
              </a:r>
            </a:p>
          </p:txBody>
        </p:sp>
        <p:sp>
          <p:nvSpPr>
            <p:cNvPr id="15" name="Freeform: Shape 14">
              <a:extLst>
                <a:ext uri="{FF2B5EF4-FFF2-40B4-BE49-F238E27FC236}">
                  <a16:creationId xmlns:a16="http://schemas.microsoft.com/office/drawing/2014/main" id="{4184813C-C86E-CC75-2C42-85DC889EF834}"/>
                </a:ext>
              </a:extLst>
            </p:cNvPr>
            <p:cNvSpPr/>
            <p:nvPr/>
          </p:nvSpPr>
          <p:spPr>
            <a:xfrm>
              <a:off x="6577800" y="4881352"/>
              <a:ext cx="1750966" cy="1225619"/>
            </a:xfrm>
            <a:custGeom>
              <a:avLst/>
              <a:gdLst>
                <a:gd name="connsiteX0" fmla="*/ 0 w 1750966"/>
                <a:gd name="connsiteY0" fmla="*/ 204311 h 1225619"/>
                <a:gd name="connsiteX1" fmla="*/ 204311 w 1750966"/>
                <a:gd name="connsiteY1" fmla="*/ 0 h 1225619"/>
                <a:gd name="connsiteX2" fmla="*/ 1546655 w 1750966"/>
                <a:gd name="connsiteY2" fmla="*/ 0 h 1225619"/>
                <a:gd name="connsiteX3" fmla="*/ 1750966 w 1750966"/>
                <a:gd name="connsiteY3" fmla="*/ 204311 h 1225619"/>
                <a:gd name="connsiteX4" fmla="*/ 1750966 w 1750966"/>
                <a:gd name="connsiteY4" fmla="*/ 1021308 h 1225619"/>
                <a:gd name="connsiteX5" fmla="*/ 1546655 w 1750966"/>
                <a:gd name="connsiteY5" fmla="*/ 1225619 h 1225619"/>
                <a:gd name="connsiteX6" fmla="*/ 204311 w 1750966"/>
                <a:gd name="connsiteY6" fmla="*/ 1225619 h 1225619"/>
                <a:gd name="connsiteX7" fmla="*/ 0 w 1750966"/>
                <a:gd name="connsiteY7" fmla="*/ 1021308 h 1225619"/>
                <a:gd name="connsiteX8" fmla="*/ 0 w 1750966"/>
                <a:gd name="connsiteY8" fmla="*/ 204311 h 12256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750966" h="1225619">
                  <a:moveTo>
                    <a:pt x="0" y="204311"/>
                  </a:moveTo>
                  <a:cubicBezTo>
                    <a:pt x="0" y="91473"/>
                    <a:pt x="91473" y="0"/>
                    <a:pt x="204311" y="0"/>
                  </a:cubicBezTo>
                  <a:lnTo>
                    <a:pt x="1546655" y="0"/>
                  </a:lnTo>
                  <a:cubicBezTo>
                    <a:pt x="1659493" y="0"/>
                    <a:pt x="1750966" y="91473"/>
                    <a:pt x="1750966" y="204311"/>
                  </a:cubicBezTo>
                  <a:lnTo>
                    <a:pt x="1750966" y="1021308"/>
                  </a:lnTo>
                  <a:cubicBezTo>
                    <a:pt x="1750966" y="1134146"/>
                    <a:pt x="1659493" y="1225619"/>
                    <a:pt x="1546655" y="1225619"/>
                  </a:cubicBezTo>
                  <a:lnTo>
                    <a:pt x="204311" y="1225619"/>
                  </a:lnTo>
                  <a:cubicBezTo>
                    <a:pt x="91473" y="1225619"/>
                    <a:pt x="0" y="1134146"/>
                    <a:pt x="0" y="1021308"/>
                  </a:cubicBezTo>
                  <a:lnTo>
                    <a:pt x="0" y="204311"/>
                  </a:lnTo>
                  <a:close/>
                </a:path>
              </a:pathLst>
            </a:cu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 spcFirstLastPara="0" vert="horz" wrap="square" lIns="132231" tIns="132231" rIns="132231" bIns="132231" numCol="1" spcCol="1270" anchor="ctr" anchorCtr="0">
              <a:noAutofit/>
            </a:bodyPr>
            <a:lstStyle/>
            <a:p>
              <a:pPr marL="0" lvl="0" indent="0" algn="ctr" defTabSz="8445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900" kern="1200" dirty="0"/>
                <a:t>ELISA/Luminex</a:t>
              </a:r>
            </a:p>
          </p:txBody>
        </p:sp>
        <p:sp>
          <p:nvSpPr>
            <p:cNvPr id="16" name="Freeform: Shape 15">
              <a:extLst>
                <a:ext uri="{FF2B5EF4-FFF2-40B4-BE49-F238E27FC236}">
                  <a16:creationId xmlns:a16="http://schemas.microsoft.com/office/drawing/2014/main" id="{2A341CBC-F87A-84FC-AAC1-5ECEB6D7BFD5}"/>
                </a:ext>
              </a:extLst>
            </p:cNvPr>
            <p:cNvSpPr/>
            <p:nvPr/>
          </p:nvSpPr>
          <p:spPr>
            <a:xfrm>
              <a:off x="8328767" y="4998243"/>
              <a:ext cx="1273486" cy="990600"/>
            </a:xfrm>
            <a:custGeom>
              <a:avLst/>
              <a:gdLst>
                <a:gd name="connsiteX0" fmla="*/ 0 w 1273486"/>
                <a:gd name="connsiteY0" fmla="*/ 0 h 990600"/>
                <a:gd name="connsiteX1" fmla="*/ 1273486 w 1273486"/>
                <a:gd name="connsiteY1" fmla="*/ 0 h 990600"/>
                <a:gd name="connsiteX2" fmla="*/ 1273486 w 1273486"/>
                <a:gd name="connsiteY2" fmla="*/ 990600 h 990600"/>
                <a:gd name="connsiteX3" fmla="*/ 0 w 1273486"/>
                <a:gd name="connsiteY3" fmla="*/ 990600 h 990600"/>
                <a:gd name="connsiteX4" fmla="*/ 0 w 1273486"/>
                <a:gd name="connsiteY4" fmla="*/ 0 h 990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273486" h="990600">
                  <a:moveTo>
                    <a:pt x="0" y="0"/>
                  </a:moveTo>
                  <a:lnTo>
                    <a:pt x="1273486" y="0"/>
                  </a:lnTo>
                  <a:lnTo>
                    <a:pt x="1273486" y="990600"/>
                  </a:lnTo>
                  <a:lnTo>
                    <a:pt x="0" y="990600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3350" tIns="133350" rIns="133350" bIns="133350" numCol="1" spcCol="1270" anchor="ctr" anchorCtr="0">
              <a:noAutofit/>
            </a:bodyPr>
            <a:lstStyle/>
            <a:p>
              <a:pPr marL="228600" lvl="1" indent="-228600" algn="l" defTabSz="120015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Char char="•"/>
              </a:pPr>
              <a:endParaRPr lang="en-US" sz="2700" kern="1200" dirty="0"/>
            </a:p>
          </p:txBody>
        </p:sp>
      </p:grpSp>
      <p:sp>
        <p:nvSpPr>
          <p:cNvPr id="17" name="Freeform: Shape 16">
            <a:extLst>
              <a:ext uri="{FF2B5EF4-FFF2-40B4-BE49-F238E27FC236}">
                <a16:creationId xmlns:a16="http://schemas.microsoft.com/office/drawing/2014/main" id="{AE192261-16A0-E41D-F274-F6237AEF8143}"/>
              </a:ext>
            </a:extLst>
          </p:cNvPr>
          <p:cNvSpPr/>
          <p:nvPr/>
        </p:nvSpPr>
        <p:spPr>
          <a:xfrm>
            <a:off x="7135818" y="3680842"/>
            <a:ext cx="2840587" cy="990600"/>
          </a:xfrm>
          <a:custGeom>
            <a:avLst/>
            <a:gdLst>
              <a:gd name="connsiteX0" fmla="*/ 0 w 2840587"/>
              <a:gd name="connsiteY0" fmla="*/ 0 h 990600"/>
              <a:gd name="connsiteX1" fmla="*/ 2840587 w 2840587"/>
              <a:gd name="connsiteY1" fmla="*/ 0 h 990600"/>
              <a:gd name="connsiteX2" fmla="*/ 2840587 w 2840587"/>
              <a:gd name="connsiteY2" fmla="*/ 990600 h 990600"/>
              <a:gd name="connsiteX3" fmla="*/ 0 w 2840587"/>
              <a:gd name="connsiteY3" fmla="*/ 990600 h 990600"/>
              <a:gd name="connsiteX4" fmla="*/ 0 w 2840587"/>
              <a:gd name="connsiteY4" fmla="*/ 0 h 990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840587" h="990600">
                <a:moveTo>
                  <a:pt x="0" y="0"/>
                </a:moveTo>
                <a:lnTo>
                  <a:pt x="2840587" y="0"/>
                </a:lnTo>
                <a:lnTo>
                  <a:pt x="2840587" y="990600"/>
                </a:lnTo>
                <a:lnTo>
                  <a:pt x="0" y="990600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45720" tIns="45720" rIns="45720" bIns="45720" numCol="1" spcCol="1270" anchor="ctr" anchorCtr="0">
            <a:noAutofit/>
          </a:bodyPr>
          <a:lstStyle/>
          <a:p>
            <a:pPr marL="114300" lvl="1" indent="-114300" algn="l" defTabSz="53340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r>
              <a:rPr lang="en-US" sz="1200" kern="1200" dirty="0"/>
              <a:t>APOC1, APOE, FSTL1, LPA replicated</a:t>
            </a:r>
            <a:endParaRPr lang="en-US" sz="1200" dirty="0"/>
          </a:p>
          <a:p>
            <a:pPr marL="114300" lvl="1" indent="-114300" algn="l" defTabSz="53340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r>
              <a:rPr lang="en-US" sz="1200" kern="1200" dirty="0"/>
              <a:t>34,875 serum samples</a:t>
            </a:r>
          </a:p>
        </p:txBody>
      </p:sp>
      <p:sp>
        <p:nvSpPr>
          <p:cNvPr id="18" name="Freeform: Shape 17">
            <a:extLst>
              <a:ext uri="{FF2B5EF4-FFF2-40B4-BE49-F238E27FC236}">
                <a16:creationId xmlns:a16="http://schemas.microsoft.com/office/drawing/2014/main" id="{CFB9AEA0-6D50-6217-D7A8-AA6594F27E28}"/>
              </a:ext>
            </a:extLst>
          </p:cNvPr>
          <p:cNvSpPr/>
          <p:nvPr/>
        </p:nvSpPr>
        <p:spPr>
          <a:xfrm>
            <a:off x="8426354" y="4936548"/>
            <a:ext cx="2840587" cy="990600"/>
          </a:xfrm>
          <a:custGeom>
            <a:avLst/>
            <a:gdLst>
              <a:gd name="connsiteX0" fmla="*/ 0 w 2840587"/>
              <a:gd name="connsiteY0" fmla="*/ 0 h 990600"/>
              <a:gd name="connsiteX1" fmla="*/ 2840587 w 2840587"/>
              <a:gd name="connsiteY1" fmla="*/ 0 h 990600"/>
              <a:gd name="connsiteX2" fmla="*/ 2840587 w 2840587"/>
              <a:gd name="connsiteY2" fmla="*/ 990600 h 990600"/>
              <a:gd name="connsiteX3" fmla="*/ 0 w 2840587"/>
              <a:gd name="connsiteY3" fmla="*/ 990600 h 990600"/>
              <a:gd name="connsiteX4" fmla="*/ 0 w 2840587"/>
              <a:gd name="connsiteY4" fmla="*/ 0 h 990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840587" h="990600">
                <a:moveTo>
                  <a:pt x="0" y="0"/>
                </a:moveTo>
                <a:lnTo>
                  <a:pt x="2840587" y="0"/>
                </a:lnTo>
                <a:lnTo>
                  <a:pt x="2840587" y="990600"/>
                </a:lnTo>
                <a:lnTo>
                  <a:pt x="0" y="990600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45720" tIns="45720" rIns="45720" bIns="45720" numCol="1" spcCol="1270" anchor="ctr" anchorCtr="0">
            <a:noAutofit/>
          </a:bodyPr>
          <a:lstStyle/>
          <a:p>
            <a:pPr marL="114300" lvl="1" indent="-114300" algn="l" defTabSz="53340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r>
              <a:rPr lang="en-US" sz="1200" kern="1200" dirty="0"/>
              <a:t>APOE, CTSG, MPO replicated</a:t>
            </a:r>
            <a:endParaRPr lang="en-US" sz="1200" dirty="0"/>
          </a:p>
          <a:p>
            <a:pPr marL="114300" lvl="1" indent="-114300" algn="l" defTabSz="53340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r>
              <a:rPr lang="en-US" sz="1200" kern="1200" dirty="0"/>
              <a:t>106 participants</a:t>
            </a:r>
          </a:p>
        </p:txBody>
      </p:sp>
      <p:sp>
        <p:nvSpPr>
          <p:cNvPr id="20" name="Arrow: Bent-Up 19">
            <a:extLst>
              <a:ext uri="{FF2B5EF4-FFF2-40B4-BE49-F238E27FC236}">
                <a16:creationId xmlns:a16="http://schemas.microsoft.com/office/drawing/2014/main" id="{72A5D6D0-783B-71DF-0D63-0310E89C9072}"/>
              </a:ext>
            </a:extLst>
          </p:cNvPr>
          <p:cNvSpPr/>
          <p:nvPr/>
        </p:nvSpPr>
        <p:spPr>
          <a:xfrm rot="10800000">
            <a:off x="1551671" y="1244874"/>
            <a:ext cx="901671" cy="2184126"/>
          </a:xfrm>
          <a:prstGeom prst="bentUpArrow">
            <a:avLst>
              <a:gd name="adj1" fmla="val 32840"/>
              <a:gd name="adj2" fmla="val 22662"/>
              <a:gd name="adj3" fmla="val 3578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tint val="50000"/>
              <a:hueOff val="0"/>
              <a:satOff val="0"/>
              <a:lumOff val="0"/>
              <a:alphaOff val="0"/>
            </a:schemeClr>
          </a:fillRef>
          <a:effectRef idx="0">
            <a:schemeClr val="accent1">
              <a:tint val="50000"/>
              <a:hueOff val="0"/>
              <a:satOff val="0"/>
              <a:lumOff val="0"/>
              <a:alphaOff val="0"/>
            </a:schemeClr>
          </a:effectRef>
          <a:fontRef idx="minor">
            <a:schemeClr val="lt1">
              <a:hueOff val="0"/>
              <a:satOff val="0"/>
              <a:lumOff val="0"/>
              <a:alphaOff val="0"/>
            </a:schemeClr>
          </a:fontRef>
        </p:style>
        <p:txBody>
          <a:bodyPr/>
          <a:lstStyle/>
          <a:p>
            <a:endParaRPr lang="en-US"/>
          </a:p>
        </p:txBody>
      </p:sp>
      <p:sp>
        <p:nvSpPr>
          <p:cNvPr id="21" name="Freeform: Shape 20">
            <a:extLst>
              <a:ext uri="{FF2B5EF4-FFF2-40B4-BE49-F238E27FC236}">
                <a16:creationId xmlns:a16="http://schemas.microsoft.com/office/drawing/2014/main" id="{C62CDEAE-AAFF-2495-544A-98963EDE7CC0}"/>
              </a:ext>
            </a:extLst>
          </p:cNvPr>
          <p:cNvSpPr/>
          <p:nvPr/>
        </p:nvSpPr>
        <p:spPr>
          <a:xfrm>
            <a:off x="797668" y="3457284"/>
            <a:ext cx="1886612" cy="1225619"/>
          </a:xfrm>
          <a:custGeom>
            <a:avLst/>
            <a:gdLst>
              <a:gd name="connsiteX0" fmla="*/ 0 w 1750966"/>
              <a:gd name="connsiteY0" fmla="*/ 204311 h 1225619"/>
              <a:gd name="connsiteX1" fmla="*/ 204311 w 1750966"/>
              <a:gd name="connsiteY1" fmla="*/ 0 h 1225619"/>
              <a:gd name="connsiteX2" fmla="*/ 1546655 w 1750966"/>
              <a:gd name="connsiteY2" fmla="*/ 0 h 1225619"/>
              <a:gd name="connsiteX3" fmla="*/ 1750966 w 1750966"/>
              <a:gd name="connsiteY3" fmla="*/ 204311 h 1225619"/>
              <a:gd name="connsiteX4" fmla="*/ 1750966 w 1750966"/>
              <a:gd name="connsiteY4" fmla="*/ 1021308 h 1225619"/>
              <a:gd name="connsiteX5" fmla="*/ 1546655 w 1750966"/>
              <a:gd name="connsiteY5" fmla="*/ 1225619 h 1225619"/>
              <a:gd name="connsiteX6" fmla="*/ 204311 w 1750966"/>
              <a:gd name="connsiteY6" fmla="*/ 1225619 h 1225619"/>
              <a:gd name="connsiteX7" fmla="*/ 0 w 1750966"/>
              <a:gd name="connsiteY7" fmla="*/ 1021308 h 1225619"/>
              <a:gd name="connsiteX8" fmla="*/ 0 w 1750966"/>
              <a:gd name="connsiteY8" fmla="*/ 204311 h 12256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750966" h="1225619">
                <a:moveTo>
                  <a:pt x="0" y="204311"/>
                </a:moveTo>
                <a:cubicBezTo>
                  <a:pt x="0" y="91473"/>
                  <a:pt x="91473" y="0"/>
                  <a:pt x="204311" y="0"/>
                </a:cubicBezTo>
                <a:lnTo>
                  <a:pt x="1546655" y="0"/>
                </a:lnTo>
                <a:cubicBezTo>
                  <a:pt x="1659493" y="0"/>
                  <a:pt x="1750966" y="91473"/>
                  <a:pt x="1750966" y="204311"/>
                </a:cubicBezTo>
                <a:lnTo>
                  <a:pt x="1750966" y="1021308"/>
                </a:lnTo>
                <a:cubicBezTo>
                  <a:pt x="1750966" y="1134146"/>
                  <a:pt x="1659493" y="1225619"/>
                  <a:pt x="1546655" y="1225619"/>
                </a:cubicBezTo>
                <a:lnTo>
                  <a:pt x="204311" y="1225619"/>
                </a:lnTo>
                <a:cubicBezTo>
                  <a:pt x="91473" y="1225619"/>
                  <a:pt x="0" y="1134146"/>
                  <a:pt x="0" y="1021308"/>
                </a:cubicBezTo>
                <a:lnTo>
                  <a:pt x="0" y="204311"/>
                </a:lnTo>
                <a:close/>
              </a:path>
            </a:pathLst>
          </a:cu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32231" tIns="132231" rIns="132231" bIns="132231" numCol="1" spcCol="1270" anchor="ctr" anchorCtr="0">
            <a:noAutofit/>
          </a:bodyPr>
          <a:lstStyle/>
          <a:p>
            <a:pPr marL="0" lvl="0" indent="0" algn="ctr" defTabSz="8445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900" kern="1200" dirty="0"/>
              <a:t>LLFS Blood transcriptomics</a:t>
            </a:r>
          </a:p>
        </p:txBody>
      </p:sp>
      <p:sp>
        <p:nvSpPr>
          <p:cNvPr id="22" name="Freeform: Shape 21">
            <a:extLst>
              <a:ext uri="{FF2B5EF4-FFF2-40B4-BE49-F238E27FC236}">
                <a16:creationId xmlns:a16="http://schemas.microsoft.com/office/drawing/2014/main" id="{EA3F5CAD-42D8-97EB-9C5E-EBB301172899}"/>
              </a:ext>
            </a:extLst>
          </p:cNvPr>
          <p:cNvSpPr/>
          <p:nvPr/>
        </p:nvSpPr>
        <p:spPr>
          <a:xfrm>
            <a:off x="797668" y="4806307"/>
            <a:ext cx="2840587" cy="990600"/>
          </a:xfrm>
          <a:custGeom>
            <a:avLst/>
            <a:gdLst>
              <a:gd name="connsiteX0" fmla="*/ 0 w 2840587"/>
              <a:gd name="connsiteY0" fmla="*/ 0 h 990600"/>
              <a:gd name="connsiteX1" fmla="*/ 2840587 w 2840587"/>
              <a:gd name="connsiteY1" fmla="*/ 0 h 990600"/>
              <a:gd name="connsiteX2" fmla="*/ 2840587 w 2840587"/>
              <a:gd name="connsiteY2" fmla="*/ 990600 h 990600"/>
              <a:gd name="connsiteX3" fmla="*/ 0 w 2840587"/>
              <a:gd name="connsiteY3" fmla="*/ 990600 h 990600"/>
              <a:gd name="connsiteX4" fmla="*/ 0 w 2840587"/>
              <a:gd name="connsiteY4" fmla="*/ 0 h 990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840587" h="990600">
                <a:moveTo>
                  <a:pt x="0" y="0"/>
                </a:moveTo>
                <a:lnTo>
                  <a:pt x="2840587" y="0"/>
                </a:lnTo>
                <a:lnTo>
                  <a:pt x="2840587" y="990600"/>
                </a:lnTo>
                <a:lnTo>
                  <a:pt x="0" y="990600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45720" tIns="45720" rIns="45720" bIns="45720" numCol="1" spcCol="1270" anchor="ctr" anchorCtr="0">
            <a:noAutofit/>
          </a:bodyPr>
          <a:lstStyle/>
          <a:p>
            <a:pPr marL="114300" lvl="1" indent="-114300" algn="l" defTabSz="53340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r>
              <a:rPr lang="en-US" sz="1200" kern="1200" dirty="0"/>
              <a:t>Concordant effects forBIRC2, LRRN1, UBA2, PSME1, VSP29, APOL1, LYZ, MPO, CAMP</a:t>
            </a:r>
            <a:endParaRPr lang="en-US" sz="1200" dirty="0"/>
          </a:p>
          <a:p>
            <a:pPr marL="114300" lvl="1" indent="-114300" algn="l" defTabSz="53340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Char char="•"/>
            </a:pPr>
            <a:r>
              <a:rPr lang="en-US" sz="1200" kern="1200" dirty="0"/>
              <a:t>1,384 participants</a:t>
            </a:r>
          </a:p>
        </p:txBody>
      </p:sp>
      <p:sp>
        <p:nvSpPr>
          <p:cNvPr id="23" name="Arrow: Right 22">
            <a:extLst>
              <a:ext uri="{FF2B5EF4-FFF2-40B4-BE49-F238E27FC236}">
                <a16:creationId xmlns:a16="http://schemas.microsoft.com/office/drawing/2014/main" id="{F74D1E68-D313-B55A-BEF4-0E79EBB1FF44}"/>
              </a:ext>
            </a:extLst>
          </p:cNvPr>
          <p:cNvSpPr/>
          <p:nvPr/>
        </p:nvSpPr>
        <p:spPr>
          <a:xfrm rot="8997973">
            <a:off x="2811499" y="3286830"/>
            <a:ext cx="1031256" cy="530864"/>
          </a:xfrm>
          <a:prstGeom prst="rightArrow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E3E141F-0148-C3B0-F83D-1C06D7229B9C}"/>
              </a:ext>
            </a:extLst>
          </p:cNvPr>
          <p:cNvSpPr/>
          <p:nvPr/>
        </p:nvSpPr>
        <p:spPr>
          <a:xfrm>
            <a:off x="619336" y="6363517"/>
            <a:ext cx="7175985" cy="3174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0000"/>
              </a:lnSpc>
              <a:spcAft>
                <a:spcPts val="600"/>
              </a:spcAft>
            </a:pPr>
            <a:r>
              <a: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 Figure S2: Flow chart of the various analysis conducted in this work</a:t>
            </a:r>
          </a:p>
        </p:txBody>
      </p:sp>
    </p:spTree>
    <p:extLst>
      <p:ext uri="{BB962C8B-B14F-4D97-AF65-F5344CB8AC3E}">
        <p14:creationId xmlns:p14="http://schemas.microsoft.com/office/powerpoint/2010/main" val="1796013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05</TotalTime>
  <Words>405</Words>
  <Application>Microsoft Office PowerPoint</Application>
  <PresentationFormat>Widescreen</PresentationFormat>
  <Paragraphs>215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Calibri Light</vt:lpstr>
      <vt:lpstr>Roboto</vt:lpstr>
      <vt:lpstr>Times New Roman</vt:lpstr>
      <vt:lpstr>Office Theme</vt:lpstr>
      <vt:lpstr>1_Office Theme</vt:lpstr>
      <vt:lpstr>Supplement figures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ola Sebastiani</dc:creator>
  <cp:lastModifiedBy>Vishnu Singh</cp:lastModifiedBy>
  <cp:revision>49</cp:revision>
  <cp:lastPrinted>2025-04-21T15:51:27Z</cp:lastPrinted>
  <dcterms:created xsi:type="dcterms:W3CDTF">2023-09-29T22:48:45Z</dcterms:created>
  <dcterms:modified xsi:type="dcterms:W3CDTF">2025-10-25T12:02:51Z</dcterms:modified>
</cp:coreProperties>
</file>